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82353"/>
  </p:normalViewPr>
  <p:slideViewPr>
    <p:cSldViewPr snapToGrid="0" snapToObjects="1">
      <p:cViewPr varScale="1">
        <p:scale>
          <a:sx n="85" d="100"/>
          <a:sy n="85" d="100"/>
        </p:scale>
        <p:origin x="10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48DBEB-15EF-6F45-B0B9-384D2E479FEC}" type="datetimeFigureOut">
              <a:rPr lang="en-US" smtClean="0"/>
              <a:t>12/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1322C4-F6F5-BF4C-AFD2-DAE037AF18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846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1: Characterization of macrophages with multiple inflammasome agonists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one marrow-derived macrophages (5× 105 cells) were plated into 24-well plates, and then cells were primed with LPS (20ng/ml) for 16 hours. Cells were then stimulated for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other 24 hours with various NLR inflammasome agonists, as indicated. Cells were stained with Pacific Blue conjugated-CD80 (C, D) and APC conjugated anti-CD86 (E,F) and flow cytometry was completed. Data are expressed as means ± SEM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&lt;0.01, p&lt;0.001, significantly different from mock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093D0C-3375-A448-A412-7A4235A6C0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1317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E5EDDF-0DE7-6848-9BC8-0FB1C81C2F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96AB81-40B5-DC4F-943D-0686F71AB5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B0D173-028C-514A-B3F1-2BE86269F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C50602-DE09-5A45-ACC3-5D6924A071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1955CA-8B48-5C48-AAF9-4DA5AFF30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163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6FC78-7461-634D-81E7-6EFEA22764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C382F3-5A78-8540-BA43-D4FCE61A75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D22B2C-E5CF-934B-910D-238A1CC0C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052E62-5526-084D-8804-05688EB56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882FC1-B89C-EC45-B027-DE421D426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142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9CECB4E-7DA7-7B42-A16C-8E93E5EFE8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59BF80-ECB2-1847-8DCE-3C951F90C1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13ADE9-07F4-4440-9ABB-7BFA69A45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4827D0-0B96-514F-94C1-3F428D67F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8FBB0F-574A-A144-9048-0CA787108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649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464B0C-1971-EC4E-8AB8-8832CC4560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1B2CFD-75F7-FF4C-B5FE-F8D90A2DBE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404BC7-8B42-7E4E-8258-5577D2B08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576092-41A2-3341-8DD5-3E68BA419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8778C1-912F-BB43-BE34-3317CA587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305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5BD16D-AB2A-CC42-BEB0-69309FF19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0604D4-E983-244E-BED9-5F928BE152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3CEC96-90EB-F34C-B914-4F8529BD8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916FF1-AF0D-FA4C-98FA-A0DCB7C69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138B67-B5F4-ED41-A55E-D727C8B30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745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61634A-963D-B841-B238-CF7E540AE7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DFFFB0-7DE9-F244-BF86-F89F900205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F4FB54-0B89-8F42-8FCE-9EBF375CD4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75896A-6743-DB48-8F0A-66F1A905A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033F85-526D-4B40-90F7-422D1D139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39E16D-1BB8-C44A-A9F9-A530FDE00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819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E0C278-1BC4-C54D-BC66-B5627321F4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2C1AED-9F87-5544-9930-018851D56A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4CCFC4-CE80-6F4C-A984-9F0EBCE492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C5916C2-9930-1C4E-ABF4-6F7886FBFB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50B17DC-6E91-344D-9EB0-D7F8BE0CB1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D08B2B-86AA-8E46-8B43-D1555B5AC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036C55-82EC-BB4C-BD7F-C2904E2E1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3CEB04-2B5B-A049-BE0C-9D793F1AF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98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BBD78-ECB0-C04A-AF0C-992014C625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BB7AF4-083E-F246-AED9-040DD4153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B4E3DE-8FE4-2841-87E7-8F5E412D1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7820DC-4C8D-BF48-9319-E257C4C56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774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CD1B60-C566-A34A-BEB3-CD8D67C3B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4CD44F-AE42-A541-B536-E62349D5E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36B224-3BC6-AB42-BBAB-01C4E9F3A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31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79D71C-FBB9-1E48-BEDC-9091C41D06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27D71A-3EB4-084F-80BB-1C90131D6F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617152-6346-214F-A033-95E929EBEA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ACDF18-219C-8448-AE27-70237A4BA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671E8A-8E69-6E47-A1E7-A50A65ED9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3E3EA4-17E9-1B47-85DB-28E870E40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89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79367-D9C3-6C48-AF38-E66EA11EDF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02AAFD-316C-CD4C-9963-3E629F75B1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E466CA-30F9-654D-BEBA-A7ECB94D3C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3BA428-D671-FC4F-8F44-81CC1C5AC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BD64B0-0213-AB4A-9BEF-250727618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C465DE-9571-FF43-8BED-BBCF0BD6E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555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87F9AA-9051-2344-812D-BBA2B9150E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68FE26-4A17-7849-A98F-FE4E5E7478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F5EFB5-74B9-5948-8414-8A43C7B66F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6DF87-21B0-CA44-B5E5-40A570901786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0EEE47-A403-2D46-B824-4A46872400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04876F-2F55-954F-AE8A-822204D323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2200C-BB1E-5746-911A-791DDFAA7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331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b="23468"/>
          <a:stretch/>
        </p:blipFill>
        <p:spPr>
          <a:xfrm>
            <a:off x="2179505" y="368741"/>
            <a:ext cx="3036509" cy="187527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6200000">
            <a:off x="1164929" y="1018996"/>
            <a:ext cx="172064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/>
              <a:t>%active caspase-1</a:t>
            </a:r>
          </a:p>
          <a:p>
            <a:pPr algn="ctr"/>
            <a:r>
              <a:rPr lang="en-US" sz="1600" b="1" dirty="0"/>
              <a:t> BMDMs 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b="15936"/>
          <a:stretch/>
        </p:blipFill>
        <p:spPr>
          <a:xfrm>
            <a:off x="7213940" y="378085"/>
            <a:ext cx="2670308" cy="187451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6032644" y="1122013"/>
            <a:ext cx="172064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/>
              <a:t>%active caspase-1</a:t>
            </a:r>
          </a:p>
          <a:p>
            <a:pPr algn="ctr"/>
            <a:r>
              <a:rPr lang="en-US" sz="1600" b="1" dirty="0"/>
              <a:t> BMDMs 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/>
          <a:srcRect b="22400"/>
          <a:stretch/>
        </p:blipFill>
        <p:spPr>
          <a:xfrm>
            <a:off x="2288896" y="2342288"/>
            <a:ext cx="2843269" cy="187452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 rot="16200000">
            <a:off x="1243012" y="3188746"/>
            <a:ext cx="1662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%CD80+ BMDMs 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6"/>
          <a:srcRect b="17361"/>
          <a:stretch/>
        </p:blipFill>
        <p:spPr>
          <a:xfrm>
            <a:off x="7131694" y="2269606"/>
            <a:ext cx="2731245" cy="1874519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 rot="16200000">
            <a:off x="6114568" y="3156799"/>
            <a:ext cx="1662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%CD80+ BMDMs 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/>
          <a:srcRect b="22118"/>
          <a:stretch/>
        </p:blipFill>
        <p:spPr>
          <a:xfrm>
            <a:off x="2253582" y="4238926"/>
            <a:ext cx="2775379" cy="187452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8"/>
          <a:srcRect b="16952"/>
          <a:stretch/>
        </p:blipFill>
        <p:spPr>
          <a:xfrm>
            <a:off x="7178795" y="4155699"/>
            <a:ext cx="2614155" cy="1874519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 rot="16200000">
            <a:off x="1212532" y="4971937"/>
            <a:ext cx="1662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%CD86+ BMDMs 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6140535" y="5136543"/>
            <a:ext cx="1662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%CD86+ BMDMs </a:t>
            </a:r>
          </a:p>
        </p:txBody>
      </p:sp>
      <p:sp>
        <p:nvSpPr>
          <p:cNvPr id="26" name="TextBox 25"/>
          <p:cNvSpPr txBox="1"/>
          <p:nvPr/>
        </p:nvSpPr>
        <p:spPr>
          <a:xfrm rot="19452363">
            <a:off x="2877883" y="6082348"/>
            <a:ext cx="4980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MDP</a:t>
            </a:r>
          </a:p>
        </p:txBody>
      </p:sp>
      <p:sp>
        <p:nvSpPr>
          <p:cNvPr id="27" name="TextBox 26"/>
          <p:cNvSpPr txBox="1"/>
          <p:nvPr/>
        </p:nvSpPr>
        <p:spPr>
          <a:xfrm rot="19452363">
            <a:off x="3145578" y="6140088"/>
            <a:ext cx="7154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Flagellin</a:t>
            </a:r>
          </a:p>
        </p:txBody>
      </p:sp>
      <p:sp>
        <p:nvSpPr>
          <p:cNvPr id="28" name="TextBox 27"/>
          <p:cNvSpPr txBox="1"/>
          <p:nvPr/>
        </p:nvSpPr>
        <p:spPr>
          <a:xfrm rot="19452363">
            <a:off x="4267280" y="6051132"/>
            <a:ext cx="523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Alum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V="1">
            <a:off x="2400745" y="6613864"/>
            <a:ext cx="2536452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2923160" y="6588257"/>
            <a:ext cx="1570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LPS (20ng/ml) primed</a:t>
            </a:r>
          </a:p>
        </p:txBody>
      </p:sp>
      <p:sp>
        <p:nvSpPr>
          <p:cNvPr id="31" name="TextBox 30"/>
          <p:cNvSpPr txBox="1"/>
          <p:nvPr/>
        </p:nvSpPr>
        <p:spPr>
          <a:xfrm rot="19452363">
            <a:off x="2303722" y="6087068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Mock</a:t>
            </a:r>
          </a:p>
        </p:txBody>
      </p:sp>
      <p:sp>
        <p:nvSpPr>
          <p:cNvPr id="32" name="TextBox 31"/>
          <p:cNvSpPr txBox="1"/>
          <p:nvPr/>
        </p:nvSpPr>
        <p:spPr>
          <a:xfrm rot="19452363">
            <a:off x="3412008" y="6164272"/>
            <a:ext cx="941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poly(dA:dT)</a:t>
            </a:r>
          </a:p>
        </p:txBody>
      </p:sp>
      <p:sp>
        <p:nvSpPr>
          <p:cNvPr id="33" name="TextBox 32"/>
          <p:cNvSpPr txBox="1"/>
          <p:nvPr/>
        </p:nvSpPr>
        <p:spPr>
          <a:xfrm rot="19452363">
            <a:off x="7538044" y="6053175"/>
            <a:ext cx="56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HKLM</a:t>
            </a:r>
          </a:p>
        </p:txBody>
      </p:sp>
      <p:sp>
        <p:nvSpPr>
          <p:cNvPr id="35" name="TextBox 34"/>
          <p:cNvSpPr txBox="1"/>
          <p:nvPr/>
        </p:nvSpPr>
        <p:spPr>
          <a:xfrm rot="19452363">
            <a:off x="8972005" y="6145446"/>
            <a:ext cx="7839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ODN CpG</a:t>
            </a:r>
          </a:p>
        </p:txBody>
      </p:sp>
      <p:cxnSp>
        <p:nvCxnSpPr>
          <p:cNvPr id="36" name="Straight Connector 35"/>
          <p:cNvCxnSpPr/>
          <p:nvPr/>
        </p:nvCxnSpPr>
        <p:spPr>
          <a:xfrm flipV="1">
            <a:off x="7337842" y="6512729"/>
            <a:ext cx="250410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7752603" y="6545159"/>
            <a:ext cx="1570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LPS (20ng/ml) primed</a:t>
            </a:r>
          </a:p>
        </p:txBody>
      </p:sp>
      <p:sp>
        <p:nvSpPr>
          <p:cNvPr id="38" name="TextBox 37"/>
          <p:cNvSpPr txBox="1"/>
          <p:nvPr/>
        </p:nvSpPr>
        <p:spPr>
          <a:xfrm rot="19452363">
            <a:off x="7173982" y="604025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Mock</a:t>
            </a:r>
          </a:p>
        </p:txBody>
      </p:sp>
      <p:sp>
        <p:nvSpPr>
          <p:cNvPr id="39" name="TextBox 38"/>
          <p:cNvSpPr txBox="1"/>
          <p:nvPr/>
        </p:nvSpPr>
        <p:spPr>
          <a:xfrm rot="19452363">
            <a:off x="8482140" y="6033175"/>
            <a:ext cx="404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LPS</a:t>
            </a:r>
          </a:p>
        </p:txBody>
      </p:sp>
      <p:sp>
        <p:nvSpPr>
          <p:cNvPr id="40" name="TextBox 39"/>
          <p:cNvSpPr txBox="1"/>
          <p:nvPr/>
        </p:nvSpPr>
        <p:spPr>
          <a:xfrm rot="19452363">
            <a:off x="7830850" y="6096563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poly(I:C)</a:t>
            </a:r>
          </a:p>
        </p:txBody>
      </p:sp>
      <p:sp>
        <p:nvSpPr>
          <p:cNvPr id="41" name="TextBox 40"/>
          <p:cNvSpPr txBox="1"/>
          <p:nvPr/>
        </p:nvSpPr>
        <p:spPr>
          <a:xfrm rot="19452363">
            <a:off x="8776527" y="6052299"/>
            <a:ext cx="5593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MPLA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509008" y="236755"/>
            <a:ext cx="402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6373934" y="322173"/>
            <a:ext cx="3859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sp>
        <p:nvSpPr>
          <p:cNvPr id="45" name="Left Bracket 44"/>
          <p:cNvSpPr/>
          <p:nvPr/>
        </p:nvSpPr>
        <p:spPr>
          <a:xfrm rot="5400000">
            <a:off x="3224137" y="871733"/>
            <a:ext cx="130994" cy="195956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46" name="TextBox 45"/>
          <p:cNvSpPr txBox="1"/>
          <p:nvPr/>
        </p:nvSpPr>
        <p:spPr>
          <a:xfrm>
            <a:off x="2895272" y="606430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48" name="Left Bracket 47"/>
          <p:cNvSpPr/>
          <p:nvPr/>
        </p:nvSpPr>
        <p:spPr>
          <a:xfrm rot="5400000">
            <a:off x="3744551" y="489145"/>
            <a:ext cx="130994" cy="195956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49" name="TextBox 48"/>
          <p:cNvSpPr txBox="1"/>
          <p:nvPr/>
        </p:nvSpPr>
        <p:spPr>
          <a:xfrm>
            <a:off x="3402174" y="210332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51" name="Left Bracket 50"/>
          <p:cNvSpPr/>
          <p:nvPr/>
        </p:nvSpPr>
        <p:spPr>
          <a:xfrm rot="5400000">
            <a:off x="4782800" y="760901"/>
            <a:ext cx="130994" cy="195956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52" name="TextBox 51"/>
          <p:cNvSpPr txBox="1"/>
          <p:nvPr/>
        </p:nvSpPr>
        <p:spPr>
          <a:xfrm>
            <a:off x="4493343" y="504977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563569" y="2183745"/>
            <a:ext cx="3747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C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6413505" y="2219027"/>
            <a:ext cx="41101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D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602171" y="4122698"/>
            <a:ext cx="3598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E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6452106" y="4157980"/>
            <a:ext cx="3494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F</a:t>
            </a:r>
          </a:p>
        </p:txBody>
      </p:sp>
      <p:sp>
        <p:nvSpPr>
          <p:cNvPr id="65" name="Left Bracket 64"/>
          <p:cNvSpPr/>
          <p:nvPr/>
        </p:nvSpPr>
        <p:spPr>
          <a:xfrm rot="5400000">
            <a:off x="8325358" y="856651"/>
            <a:ext cx="130994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66" name="TextBox 65"/>
          <p:cNvSpPr txBox="1"/>
          <p:nvPr/>
        </p:nvSpPr>
        <p:spPr>
          <a:xfrm>
            <a:off x="8078855" y="597842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69" name="Left Bracket 68"/>
          <p:cNvSpPr/>
          <p:nvPr/>
        </p:nvSpPr>
        <p:spPr>
          <a:xfrm rot="5400000">
            <a:off x="9125168" y="1126073"/>
            <a:ext cx="130994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70" name="TextBox 69"/>
          <p:cNvSpPr txBox="1"/>
          <p:nvPr/>
        </p:nvSpPr>
        <p:spPr>
          <a:xfrm>
            <a:off x="8904561" y="863133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74" name="Left Bracket 73"/>
          <p:cNvSpPr/>
          <p:nvPr/>
        </p:nvSpPr>
        <p:spPr>
          <a:xfrm rot="5400000">
            <a:off x="2671733" y="5158249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75" name="TextBox 74"/>
          <p:cNvSpPr txBox="1"/>
          <p:nvPr/>
        </p:nvSpPr>
        <p:spPr>
          <a:xfrm>
            <a:off x="2418050" y="4929673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77" name="Left Bracket 76"/>
          <p:cNvSpPr/>
          <p:nvPr/>
        </p:nvSpPr>
        <p:spPr>
          <a:xfrm rot="5400000">
            <a:off x="3170007" y="5302634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78" name="TextBox 77"/>
          <p:cNvSpPr txBox="1"/>
          <p:nvPr/>
        </p:nvSpPr>
        <p:spPr>
          <a:xfrm>
            <a:off x="2916324" y="5057951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80" name="Left Bracket 79"/>
          <p:cNvSpPr/>
          <p:nvPr/>
        </p:nvSpPr>
        <p:spPr>
          <a:xfrm rot="5400000">
            <a:off x="3648047" y="5417101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81" name="TextBox 80"/>
          <p:cNvSpPr txBox="1"/>
          <p:nvPr/>
        </p:nvSpPr>
        <p:spPr>
          <a:xfrm>
            <a:off x="3369941" y="5194069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83" name="Left Bracket 82"/>
          <p:cNvSpPr/>
          <p:nvPr/>
        </p:nvSpPr>
        <p:spPr>
          <a:xfrm rot="5400000">
            <a:off x="4632520" y="5052132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84" name="TextBox 83"/>
          <p:cNvSpPr txBox="1"/>
          <p:nvPr/>
        </p:nvSpPr>
        <p:spPr>
          <a:xfrm>
            <a:off x="4346273" y="4820959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88" name="Left Bracket 87"/>
          <p:cNvSpPr/>
          <p:nvPr/>
        </p:nvSpPr>
        <p:spPr>
          <a:xfrm rot="5400000">
            <a:off x="2697027" y="3230593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89" name="TextBox 88"/>
          <p:cNvSpPr txBox="1"/>
          <p:nvPr/>
        </p:nvSpPr>
        <p:spPr>
          <a:xfrm>
            <a:off x="2455674" y="2988507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91" name="Left Bracket 90"/>
          <p:cNvSpPr/>
          <p:nvPr/>
        </p:nvSpPr>
        <p:spPr>
          <a:xfrm rot="5400000">
            <a:off x="3207631" y="3037371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92" name="TextBox 91"/>
          <p:cNvSpPr txBox="1"/>
          <p:nvPr/>
        </p:nvSpPr>
        <p:spPr>
          <a:xfrm>
            <a:off x="2916958" y="2807379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93" name="Left Bracket 92"/>
          <p:cNvSpPr/>
          <p:nvPr/>
        </p:nvSpPr>
        <p:spPr>
          <a:xfrm rot="5400000">
            <a:off x="3722661" y="2919949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94" name="TextBox 93"/>
          <p:cNvSpPr txBox="1"/>
          <p:nvPr/>
        </p:nvSpPr>
        <p:spPr>
          <a:xfrm>
            <a:off x="3440416" y="2704449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95" name="Left Bracket 94"/>
          <p:cNvSpPr/>
          <p:nvPr/>
        </p:nvSpPr>
        <p:spPr>
          <a:xfrm rot="5400000">
            <a:off x="4712526" y="2502078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96" name="TextBox 95"/>
          <p:cNvSpPr txBox="1"/>
          <p:nvPr/>
        </p:nvSpPr>
        <p:spPr>
          <a:xfrm>
            <a:off x="4430281" y="2300088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103" name="Left Bracket 102"/>
          <p:cNvSpPr/>
          <p:nvPr/>
        </p:nvSpPr>
        <p:spPr>
          <a:xfrm rot="5400000">
            <a:off x="7525537" y="3397616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04" name="TextBox 103"/>
          <p:cNvSpPr txBox="1"/>
          <p:nvPr/>
        </p:nvSpPr>
        <p:spPr>
          <a:xfrm>
            <a:off x="7345834" y="3181369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105" name="Left Bracket 104"/>
          <p:cNvSpPr/>
          <p:nvPr/>
        </p:nvSpPr>
        <p:spPr>
          <a:xfrm rot="5400000">
            <a:off x="8709539" y="3039234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06" name="TextBox 105"/>
          <p:cNvSpPr txBox="1"/>
          <p:nvPr/>
        </p:nvSpPr>
        <p:spPr>
          <a:xfrm>
            <a:off x="8468186" y="2822987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107" name="Left Bracket 106"/>
          <p:cNvSpPr/>
          <p:nvPr/>
        </p:nvSpPr>
        <p:spPr>
          <a:xfrm rot="5400000">
            <a:off x="9097467" y="3252800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08" name="TextBox 107"/>
          <p:cNvSpPr txBox="1"/>
          <p:nvPr/>
        </p:nvSpPr>
        <p:spPr>
          <a:xfrm>
            <a:off x="8843784" y="3024224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5</a:t>
            </a:r>
          </a:p>
        </p:txBody>
      </p:sp>
      <p:sp>
        <p:nvSpPr>
          <p:cNvPr id="109" name="Left Bracket 108"/>
          <p:cNvSpPr/>
          <p:nvPr/>
        </p:nvSpPr>
        <p:spPr>
          <a:xfrm rot="5400000">
            <a:off x="9503627" y="3282147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10" name="TextBox 109"/>
          <p:cNvSpPr txBox="1"/>
          <p:nvPr/>
        </p:nvSpPr>
        <p:spPr>
          <a:xfrm>
            <a:off x="9274604" y="309055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118" name="Left Bracket 117"/>
          <p:cNvSpPr/>
          <p:nvPr/>
        </p:nvSpPr>
        <p:spPr>
          <a:xfrm rot="5400000">
            <a:off x="7505761" y="4742433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19" name="TextBox 118"/>
          <p:cNvSpPr txBox="1"/>
          <p:nvPr/>
        </p:nvSpPr>
        <p:spPr>
          <a:xfrm>
            <a:off x="7313728" y="4513857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120" name="Left Bracket 119"/>
          <p:cNvSpPr/>
          <p:nvPr/>
        </p:nvSpPr>
        <p:spPr>
          <a:xfrm rot="5400000">
            <a:off x="7874690" y="4388489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21" name="TextBox 120"/>
          <p:cNvSpPr txBox="1"/>
          <p:nvPr/>
        </p:nvSpPr>
        <p:spPr>
          <a:xfrm>
            <a:off x="7621007" y="4173423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124" name="Left Bracket 123"/>
          <p:cNvSpPr/>
          <p:nvPr/>
        </p:nvSpPr>
        <p:spPr>
          <a:xfrm rot="5400000">
            <a:off x="8653219" y="4380540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25" name="TextBox 124"/>
          <p:cNvSpPr txBox="1"/>
          <p:nvPr/>
        </p:nvSpPr>
        <p:spPr>
          <a:xfrm>
            <a:off x="8399536" y="4178984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01</a:t>
            </a:r>
          </a:p>
        </p:txBody>
      </p:sp>
      <p:sp>
        <p:nvSpPr>
          <p:cNvPr id="126" name="Left Bracket 125"/>
          <p:cNvSpPr/>
          <p:nvPr/>
        </p:nvSpPr>
        <p:spPr>
          <a:xfrm rot="5400000">
            <a:off x="8263300" y="4809157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27" name="TextBox 126"/>
          <p:cNvSpPr txBox="1"/>
          <p:nvPr/>
        </p:nvSpPr>
        <p:spPr>
          <a:xfrm>
            <a:off x="8046607" y="4553561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128" name="Left Bracket 127"/>
          <p:cNvSpPr/>
          <p:nvPr/>
        </p:nvSpPr>
        <p:spPr>
          <a:xfrm rot="5400000">
            <a:off x="9033915" y="5129914"/>
            <a:ext cx="121850" cy="195958"/>
          </a:xfrm>
          <a:prstGeom prst="leftBracke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29" name="TextBox 128"/>
          <p:cNvSpPr txBox="1"/>
          <p:nvPr/>
        </p:nvSpPr>
        <p:spPr>
          <a:xfrm>
            <a:off x="8817222" y="490133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&lt;0.01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342782" y="-71745"/>
            <a:ext cx="2676269" cy="449309"/>
          </a:xfrm>
          <a:prstGeom prst="rect">
            <a:avLst/>
          </a:prstGeom>
          <a:noFill/>
        </p:spPr>
        <p:txBody>
          <a:bodyPr wrap="none" lIns="79204" tIns="39602" rIns="79204" bIns="39602" rtlCol="0">
            <a:spAutoFit/>
          </a:bodyPr>
          <a:lstStyle/>
          <a:p>
            <a:r>
              <a:rPr lang="en-US" sz="2400" b="1" dirty="0">
                <a:solidFill>
                  <a:srgbClr val="000000"/>
                </a:solidFill>
              </a:rPr>
              <a:t>Supplemental Fig. 1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F258B0A-D153-3949-AA8C-FB51F6055598}"/>
              </a:ext>
            </a:extLst>
          </p:cNvPr>
          <p:cNvSpPr txBox="1"/>
          <p:nvPr/>
        </p:nvSpPr>
        <p:spPr>
          <a:xfrm>
            <a:off x="6160733" y="130174"/>
            <a:ext cx="291373" cy="216449"/>
          </a:xfrm>
          <a:prstGeom prst="rect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txBody>
          <a:bodyPr wrap="square" lIns="79204" tIns="39602" rIns="79204" bIns="39602" rtlCol="0">
            <a:spAutoFit/>
          </a:bodyPr>
          <a:lstStyle/>
          <a:p>
            <a:endParaRPr lang="en-US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DA2B33EC-4639-4742-BED3-9B1F46B6D146}"/>
              </a:ext>
            </a:extLst>
          </p:cNvPr>
          <p:cNvSpPr txBox="1"/>
          <p:nvPr/>
        </p:nvSpPr>
        <p:spPr>
          <a:xfrm>
            <a:off x="4850356" y="129145"/>
            <a:ext cx="317538" cy="217478"/>
          </a:xfrm>
          <a:prstGeom prst="rect">
            <a:avLst/>
          </a:prstGeom>
          <a:solidFill>
            <a:schemeClr val="bg1"/>
          </a:solidFill>
          <a:ln>
            <a:solidFill>
              <a:srgbClr val="000000"/>
            </a:solidFill>
          </a:ln>
          <a:effectLst/>
        </p:spPr>
        <p:txBody>
          <a:bodyPr wrap="square" lIns="79204" tIns="39602" rIns="79204" bIns="39602" rtlCol="0">
            <a:spAutoFit/>
          </a:bodyPr>
          <a:lstStyle/>
          <a:p>
            <a:endParaRPr lang="en-US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A389141-F450-5F4F-B820-C7054E6F9862}"/>
              </a:ext>
            </a:extLst>
          </p:cNvPr>
          <p:cNvSpPr txBox="1"/>
          <p:nvPr/>
        </p:nvSpPr>
        <p:spPr>
          <a:xfrm>
            <a:off x="6569647" y="13955"/>
            <a:ext cx="1118551" cy="387754"/>
          </a:xfrm>
          <a:prstGeom prst="rect">
            <a:avLst/>
          </a:prstGeom>
          <a:noFill/>
        </p:spPr>
        <p:txBody>
          <a:bodyPr wrap="none" lIns="79204" tIns="39602" rIns="79204" bIns="39602" rtlCol="0">
            <a:spAutoFit/>
          </a:bodyPr>
          <a:lstStyle/>
          <a:p>
            <a:r>
              <a:rPr lang="en-US" sz="2000" b="1" dirty="0"/>
              <a:t>ERAP1-/-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2882561A-20E0-674B-8A6E-90C02C73BFF7}"/>
              </a:ext>
            </a:extLst>
          </p:cNvPr>
          <p:cNvSpPr txBox="1"/>
          <p:nvPr/>
        </p:nvSpPr>
        <p:spPr>
          <a:xfrm>
            <a:off x="5258582" y="-11394"/>
            <a:ext cx="519028" cy="387754"/>
          </a:xfrm>
          <a:prstGeom prst="rect">
            <a:avLst/>
          </a:prstGeom>
          <a:noFill/>
        </p:spPr>
        <p:txBody>
          <a:bodyPr wrap="none" lIns="79204" tIns="39602" rIns="79204" bIns="39602" rtlCol="0">
            <a:spAutoFit/>
          </a:bodyPr>
          <a:lstStyle/>
          <a:p>
            <a:r>
              <a:rPr lang="en-US" sz="2000" b="1" dirty="0"/>
              <a:t>WT</a:t>
            </a:r>
          </a:p>
        </p:txBody>
      </p:sp>
    </p:spTree>
    <p:extLst>
      <p:ext uri="{BB962C8B-B14F-4D97-AF65-F5344CB8AC3E}">
        <p14:creationId xmlns:p14="http://schemas.microsoft.com/office/powerpoint/2010/main" val="1348514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57</TotalTime>
  <Words>250</Words>
  <Application>Microsoft Macintosh PowerPoint</Application>
  <PresentationFormat>Widescreen</PresentationFormat>
  <Paragraphs>5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ake, Maja</dc:creator>
  <cp:lastModifiedBy>Blake, Maja</cp:lastModifiedBy>
  <cp:revision>15</cp:revision>
  <dcterms:created xsi:type="dcterms:W3CDTF">2020-02-25T14:09:22Z</dcterms:created>
  <dcterms:modified xsi:type="dcterms:W3CDTF">2021-12-02T15:06:24Z</dcterms:modified>
</cp:coreProperties>
</file>